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4" r:id="rId2"/>
  </p:sldIdLst>
  <p:sldSz cx="9144000" cy="6858000" type="screen4x3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5591" autoAdjust="0"/>
    <p:restoredTop sz="94629" autoAdjust="0"/>
  </p:normalViewPr>
  <p:slideViewPr>
    <p:cSldViewPr>
      <p:cViewPr>
        <p:scale>
          <a:sx n="160" d="100"/>
          <a:sy n="160" d="100"/>
        </p:scale>
        <p:origin x="-252" y="20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opy%20of%20eiwit%20CH%20+%20EE%20CsA%20pilot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opy%20of%20eiwit%20CH%20+%20EE%20CsA%20pilot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opy%20of%20ATP%20Chlorprom%20+%20eth%20estra%20csa%20pilot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opy%20of%20ATP%20Chlorprom%20+%20eth%20estra%20csa%20pilot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LDH%20CsA%20pilot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opy%20of%20ee%20and%20chlor%20ldh%20pilot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protein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protein for paper'!$C$99:$C$103</c:f>
                <c:numCache>
                  <c:formatCode>General</c:formatCode>
                  <c:ptCount val="5"/>
                  <c:pt idx="0">
                    <c:v>87.458172420000025</c:v>
                  </c:pt>
                  <c:pt idx="1">
                    <c:v>81.507780000000011</c:v>
                  </c:pt>
                  <c:pt idx="2">
                    <c:v>100.44432000000002</c:v>
                  </c:pt>
                  <c:pt idx="3">
                    <c:v>98.284890000000004</c:v>
                  </c:pt>
                  <c:pt idx="4">
                    <c:v>81.673890000000014</c:v>
                  </c:pt>
                </c:numCache>
              </c:numRef>
            </c:plus>
            <c:minus>
              <c:numRef>
                <c:f>'protein for paper'!$C$99:$C$103</c:f>
                <c:numCache>
                  <c:formatCode>General</c:formatCode>
                  <c:ptCount val="5"/>
                  <c:pt idx="0">
                    <c:v>87.458172420000025</c:v>
                  </c:pt>
                  <c:pt idx="1">
                    <c:v>81.507780000000011</c:v>
                  </c:pt>
                  <c:pt idx="2">
                    <c:v>100.44432000000002</c:v>
                  </c:pt>
                  <c:pt idx="3">
                    <c:v>98.284890000000004</c:v>
                  </c:pt>
                  <c:pt idx="4">
                    <c:v>81.673890000000014</c:v>
                  </c:pt>
                </c:numCache>
              </c:numRef>
            </c:minus>
          </c:errBars>
          <c:cat>
            <c:strRef>
              <c:f>'protein for paper'!$B$99:$B$103</c:f>
              <c:strCache>
                <c:ptCount val="5"/>
                <c:pt idx="0">
                  <c:v>ctr CsA</c:v>
                </c:pt>
                <c:pt idx="1">
                  <c:v>CsA 1 µM</c:v>
                </c:pt>
                <c:pt idx="2">
                  <c:v>CsA 2 µM</c:v>
                </c:pt>
                <c:pt idx="3">
                  <c:v>CsA 40 µM</c:v>
                </c:pt>
                <c:pt idx="4">
                  <c:v>CsA 100µM</c:v>
                </c:pt>
              </c:strCache>
            </c:strRef>
          </c:cat>
          <c:val>
            <c:numRef>
              <c:f>'protein for paper'!$E$99:$E$103</c:f>
              <c:numCache>
                <c:formatCode>General</c:formatCode>
                <c:ptCount val="5"/>
                <c:pt idx="0">
                  <c:v>777.40597706666688</c:v>
                </c:pt>
                <c:pt idx="1">
                  <c:v>724.51360000000011</c:v>
                </c:pt>
                <c:pt idx="2">
                  <c:v>892.83840000000021</c:v>
                </c:pt>
                <c:pt idx="3">
                  <c:v>873.64346666666665</c:v>
                </c:pt>
                <c:pt idx="4">
                  <c:v>725.990133333333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764608"/>
        <c:axId val="171820160"/>
      </c:barChart>
      <c:catAx>
        <c:axId val="1497646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1820160"/>
        <c:crosses val="autoZero"/>
        <c:auto val="1"/>
        <c:lblAlgn val="ctr"/>
        <c:lblOffset val="100"/>
        <c:noMultiLvlLbl val="0"/>
      </c:catAx>
      <c:valAx>
        <c:axId val="1718201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protein (µg/slic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97646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protein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protein for paper'!$I$107:$I$111</c:f>
                <c:numCache>
                  <c:formatCode>General</c:formatCode>
                  <c:ptCount val="5"/>
                  <c:pt idx="0">
                    <c:v>69.543632629085337</c:v>
                  </c:pt>
                  <c:pt idx="1">
                    <c:v>140.35801824745357</c:v>
                  </c:pt>
                  <c:pt idx="2">
                    <c:v>117.80995871071705</c:v>
                  </c:pt>
                  <c:pt idx="3">
                    <c:v>193.31778775066869</c:v>
                  </c:pt>
                  <c:pt idx="4">
                    <c:v>0.20175988627622909</c:v>
                  </c:pt>
                </c:numCache>
              </c:numRef>
            </c:plus>
            <c:minus>
              <c:numRef>
                <c:f>'protein for paper'!$I$107:$I$111</c:f>
                <c:numCache>
                  <c:formatCode>General</c:formatCode>
                  <c:ptCount val="5"/>
                  <c:pt idx="0">
                    <c:v>69.543632629085337</c:v>
                  </c:pt>
                  <c:pt idx="1">
                    <c:v>140.35801824745357</c:v>
                  </c:pt>
                  <c:pt idx="2">
                    <c:v>117.80995871071705</c:v>
                  </c:pt>
                  <c:pt idx="3">
                    <c:v>193.31778775066869</c:v>
                  </c:pt>
                  <c:pt idx="4">
                    <c:v>0.20175988627622909</c:v>
                  </c:pt>
                </c:numCache>
              </c:numRef>
            </c:minus>
          </c:errBars>
          <c:cat>
            <c:strRef>
              <c:f>'protein for paper'!$B$107:$B$111</c:f>
              <c:strCache>
                <c:ptCount val="5"/>
                <c:pt idx="0">
                  <c:v>ctr CPZ</c:v>
                </c:pt>
                <c:pt idx="1">
                  <c:v>CPZ 2 µM</c:v>
                </c:pt>
                <c:pt idx="2">
                  <c:v>CPZ 4 µM</c:v>
                </c:pt>
                <c:pt idx="3">
                  <c:v>CPZ 20 µM</c:v>
                </c:pt>
                <c:pt idx="4">
                  <c:v>CPZ 80 µM</c:v>
                </c:pt>
              </c:strCache>
            </c:strRef>
          </c:cat>
          <c:val>
            <c:numRef>
              <c:f>'protein for paper'!$H$107:$H$111</c:f>
              <c:numCache>
                <c:formatCode>General</c:formatCode>
                <c:ptCount val="5"/>
                <c:pt idx="0">
                  <c:v>789.33645714285706</c:v>
                </c:pt>
                <c:pt idx="1">
                  <c:v>800.72685714285717</c:v>
                </c:pt>
                <c:pt idx="2">
                  <c:v>801.35965714285726</c:v>
                </c:pt>
                <c:pt idx="3">
                  <c:v>730.48605714285713</c:v>
                </c:pt>
                <c:pt idx="4">
                  <c:v>109.076457142857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765632"/>
        <c:axId val="171821888"/>
      </c:barChart>
      <c:catAx>
        <c:axId val="1497656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1821888"/>
        <c:crosses val="autoZero"/>
        <c:auto val="1"/>
        <c:lblAlgn val="ctr"/>
        <c:lblOffset val="100"/>
        <c:noMultiLvlLbl val="0"/>
      </c:catAx>
      <c:valAx>
        <c:axId val="1718218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protein (µg/slic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97656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Z$107:$Z$111</c:f>
                <c:numCache>
                  <c:formatCode>General</c:formatCode>
                  <c:ptCount val="5"/>
                  <c:pt idx="0">
                    <c:v>8.6849350536324407E-2</c:v>
                  </c:pt>
                  <c:pt idx="1">
                    <c:v>0.63154737085404311</c:v>
                  </c:pt>
                  <c:pt idx="2">
                    <c:v>0.5272996282562542</c:v>
                  </c:pt>
                  <c:pt idx="3">
                    <c:v>1.0209133274478603</c:v>
                  </c:pt>
                  <c:pt idx="4">
                    <c:v>0.13364318164425784</c:v>
                  </c:pt>
                </c:numCache>
              </c:numRef>
            </c:plus>
            <c:minus>
              <c:numRef>
                <c:f>Sheet1!$Z$107:$Z$111</c:f>
                <c:numCache>
                  <c:formatCode>General</c:formatCode>
                  <c:ptCount val="5"/>
                  <c:pt idx="0">
                    <c:v>8.6849350536324407E-2</c:v>
                  </c:pt>
                  <c:pt idx="1">
                    <c:v>0.63154737085404311</c:v>
                  </c:pt>
                  <c:pt idx="2">
                    <c:v>0.5272996282562542</c:v>
                  </c:pt>
                  <c:pt idx="3">
                    <c:v>1.0209133274478603</c:v>
                  </c:pt>
                  <c:pt idx="4">
                    <c:v>0.13364318164425784</c:v>
                  </c:pt>
                </c:numCache>
              </c:numRef>
            </c:minus>
          </c:errBars>
          <c:cat>
            <c:strRef>
              <c:f>Sheet1!$S$107:$S$111</c:f>
              <c:strCache>
                <c:ptCount val="5"/>
                <c:pt idx="0">
                  <c:v>ctr CsA</c:v>
                </c:pt>
                <c:pt idx="1">
                  <c:v>CsA 1 µM</c:v>
                </c:pt>
                <c:pt idx="2">
                  <c:v>CsA 2 µM</c:v>
                </c:pt>
                <c:pt idx="3">
                  <c:v>CsA 40 µM</c:v>
                </c:pt>
                <c:pt idx="4">
                  <c:v>CsA 100µM</c:v>
                </c:pt>
              </c:strCache>
            </c:strRef>
          </c:cat>
          <c:val>
            <c:numRef>
              <c:f>Sheet1!$X$107:$X$111</c:f>
              <c:numCache>
                <c:formatCode>General</c:formatCode>
                <c:ptCount val="5"/>
                <c:pt idx="0">
                  <c:v>3.6465882352941179</c:v>
                </c:pt>
                <c:pt idx="1">
                  <c:v>3.1620000000000004</c:v>
                </c:pt>
                <c:pt idx="2">
                  <c:v>2.9648571428571433</c:v>
                </c:pt>
                <c:pt idx="3">
                  <c:v>3.7572631578947373</c:v>
                </c:pt>
                <c:pt idx="4">
                  <c:v>3.1203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27584"/>
        <c:axId val="171824192"/>
      </c:barChart>
      <c:catAx>
        <c:axId val="1498275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1824192"/>
        <c:crosses val="autoZero"/>
        <c:auto val="1"/>
        <c:lblAlgn val="ctr"/>
        <c:lblOffset val="100"/>
        <c:noMultiLvlLbl val="0"/>
      </c:catAx>
      <c:valAx>
        <c:axId val="171824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/>
                  <a:t>ATP (nmol/slice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765875619714202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498275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S$22:$S$26</c:f>
                <c:numCache>
                  <c:formatCode>General</c:formatCode>
                  <c:ptCount val="5"/>
                  <c:pt idx="0">
                    <c:v>0.13323371382649343</c:v>
                  </c:pt>
                  <c:pt idx="1">
                    <c:v>0.25539181707641234</c:v>
                  </c:pt>
                  <c:pt idx="2">
                    <c:v>0.61125845699670689</c:v>
                  </c:pt>
                  <c:pt idx="3">
                    <c:v>0.9533213623957022</c:v>
                  </c:pt>
                  <c:pt idx="4">
                    <c:v>1.8012282560046659E-2</c:v>
                  </c:pt>
                </c:numCache>
              </c:numRef>
            </c:plus>
            <c:minus>
              <c:numRef>
                <c:f>Sheet1!$S$22:$S$26</c:f>
                <c:numCache>
                  <c:formatCode>General</c:formatCode>
                  <c:ptCount val="5"/>
                  <c:pt idx="0">
                    <c:v>0.13323371382649343</c:v>
                  </c:pt>
                  <c:pt idx="1">
                    <c:v>0.25539181707641234</c:v>
                  </c:pt>
                  <c:pt idx="2">
                    <c:v>0.61125845699670689</c:v>
                  </c:pt>
                  <c:pt idx="3">
                    <c:v>0.9533213623957022</c:v>
                  </c:pt>
                  <c:pt idx="4">
                    <c:v>1.8012282560046659E-2</c:v>
                  </c:pt>
                </c:numCache>
              </c:numRef>
            </c:minus>
          </c:errBars>
          <c:cat>
            <c:strRef>
              <c:f>Sheet1!$O$22:$O$26</c:f>
              <c:strCache>
                <c:ptCount val="5"/>
                <c:pt idx="0">
                  <c:v>ctr CPZ</c:v>
                </c:pt>
                <c:pt idx="1">
                  <c:v>CPZ 2 µM</c:v>
                </c:pt>
                <c:pt idx="2">
                  <c:v>CPZ 4 µM</c:v>
                </c:pt>
                <c:pt idx="3">
                  <c:v>CPZ 20 µM</c:v>
                </c:pt>
                <c:pt idx="4">
                  <c:v>CPZ 80 µM</c:v>
                </c:pt>
              </c:strCache>
            </c:strRef>
          </c:cat>
          <c:val>
            <c:numRef>
              <c:f>Sheet1!$R$22:$R$26</c:f>
              <c:numCache>
                <c:formatCode>General</c:formatCode>
                <c:ptCount val="5"/>
                <c:pt idx="0">
                  <c:v>3.877075</c:v>
                </c:pt>
                <c:pt idx="1">
                  <c:v>3.2428392857142856</c:v>
                </c:pt>
                <c:pt idx="2">
                  <c:v>4.0029750000000002</c:v>
                </c:pt>
                <c:pt idx="3">
                  <c:v>4.4667000000000003</c:v>
                </c:pt>
                <c:pt idx="4">
                  <c:v>0.600549107142857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28096"/>
        <c:axId val="171825920"/>
      </c:barChart>
      <c:catAx>
        <c:axId val="1498280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1825920"/>
        <c:crosses val="autoZero"/>
        <c:auto val="1"/>
        <c:lblAlgn val="ctr"/>
        <c:lblOffset val="100"/>
        <c:noMultiLvlLbl val="0"/>
      </c:catAx>
      <c:valAx>
        <c:axId val="1718259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(nmol/slic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98280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LDH leakage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F$68:$F$73</c:f>
                <c:numCache>
                  <c:formatCode>General</c:formatCode>
                  <c:ptCount val="6"/>
                  <c:pt idx="0">
                    <c:v>0.10606601717798222</c:v>
                  </c:pt>
                  <c:pt idx="1">
                    <c:v>2.1213203435596444E-2</c:v>
                  </c:pt>
                  <c:pt idx="2">
                    <c:v>5.5861435713736987E-2</c:v>
                  </c:pt>
                  <c:pt idx="3">
                    <c:v>2.8991378028648436E-2</c:v>
                  </c:pt>
                  <c:pt idx="4">
                    <c:v>3.3234018715767762E-2</c:v>
                  </c:pt>
                  <c:pt idx="5">
                    <c:v>4.9497474683058368E-3</c:v>
                  </c:pt>
                </c:numCache>
              </c:numRef>
            </c:plus>
            <c:minus>
              <c:numRef>
                <c:f>Sheet1!$F$68:$F$73</c:f>
                <c:numCache>
                  <c:formatCode>General</c:formatCode>
                  <c:ptCount val="6"/>
                  <c:pt idx="0">
                    <c:v>0.10606601717798222</c:v>
                  </c:pt>
                  <c:pt idx="1">
                    <c:v>2.1213203435596444E-2</c:v>
                  </c:pt>
                  <c:pt idx="2">
                    <c:v>5.5861435713736987E-2</c:v>
                  </c:pt>
                  <c:pt idx="3">
                    <c:v>2.8991378028648436E-2</c:v>
                  </c:pt>
                  <c:pt idx="4">
                    <c:v>3.3234018715767762E-2</c:v>
                  </c:pt>
                  <c:pt idx="5">
                    <c:v>4.9497474683058368E-3</c:v>
                  </c:pt>
                </c:numCache>
              </c:numRef>
            </c:minus>
          </c:errBars>
          <c:cat>
            <c:strRef>
              <c:f>Sheet1!$B$68:$B$73</c:f>
              <c:strCache>
                <c:ptCount val="6"/>
                <c:pt idx="0">
                  <c:v>total LDH</c:v>
                </c:pt>
                <c:pt idx="1">
                  <c:v>ctr CsA</c:v>
                </c:pt>
                <c:pt idx="2">
                  <c:v>CsA 1 µM</c:v>
                </c:pt>
                <c:pt idx="3">
                  <c:v>CsA 2 µM</c:v>
                </c:pt>
                <c:pt idx="4">
                  <c:v>CsA 40 µM</c:v>
                </c:pt>
                <c:pt idx="5">
                  <c:v>CsA 100µM</c:v>
                </c:pt>
              </c:strCache>
            </c:strRef>
          </c:cat>
          <c:val>
            <c:numRef>
              <c:f>Sheet1!$E$68:$E$73</c:f>
              <c:numCache>
                <c:formatCode>General</c:formatCode>
                <c:ptCount val="6"/>
                <c:pt idx="0">
                  <c:v>1.7250000000000001</c:v>
                </c:pt>
                <c:pt idx="1">
                  <c:v>0.32400000000000001</c:v>
                </c:pt>
                <c:pt idx="2">
                  <c:v>0.36550000000000005</c:v>
                </c:pt>
                <c:pt idx="3">
                  <c:v>0.41049999999999998</c:v>
                </c:pt>
                <c:pt idx="4">
                  <c:v>0.50750000000000006</c:v>
                </c:pt>
                <c:pt idx="5">
                  <c:v>0.40250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28608"/>
        <c:axId val="143089664"/>
      </c:barChart>
      <c:catAx>
        <c:axId val="1498286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strike="noStrike"/>
            </a:pPr>
            <a:endParaRPr lang="en-US"/>
          </a:p>
        </c:txPr>
        <c:crossAx val="143089664"/>
        <c:crosses val="autoZero"/>
        <c:auto val="1"/>
        <c:lblAlgn val="ctr"/>
        <c:lblOffset val="100"/>
        <c:noMultiLvlLbl val="0"/>
      </c:catAx>
      <c:valAx>
        <c:axId val="1430896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bsorba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98286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LDH leakage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I$85:$I$90</c:f>
                <c:numCache>
                  <c:formatCode>General</c:formatCode>
                  <c:ptCount val="6"/>
                  <c:pt idx="0">
                    <c:v>0.10606601717798222</c:v>
                  </c:pt>
                  <c:pt idx="1">
                    <c:v>3.6923344016128394E-2</c:v>
                  </c:pt>
                  <c:pt idx="2">
                    <c:v>4.9497474683058124E-2</c:v>
                  </c:pt>
                  <c:pt idx="3">
                    <c:v>3.181980515339463E-2</c:v>
                  </c:pt>
                  <c:pt idx="4">
                    <c:v>5.3740115370177366E-2</c:v>
                  </c:pt>
                  <c:pt idx="5">
                    <c:v>4.2426406871192889E-2</c:v>
                  </c:pt>
                </c:numCache>
              </c:numRef>
            </c:plus>
            <c:minus>
              <c:numRef>
                <c:f>Sheet1!$I$85:$I$90</c:f>
                <c:numCache>
                  <c:formatCode>General</c:formatCode>
                  <c:ptCount val="6"/>
                  <c:pt idx="0">
                    <c:v>0.10606601717798222</c:v>
                  </c:pt>
                  <c:pt idx="1">
                    <c:v>3.6923344016128394E-2</c:v>
                  </c:pt>
                  <c:pt idx="2">
                    <c:v>4.9497474683058124E-2</c:v>
                  </c:pt>
                  <c:pt idx="3">
                    <c:v>3.181980515339463E-2</c:v>
                  </c:pt>
                  <c:pt idx="4">
                    <c:v>5.3740115370177366E-2</c:v>
                  </c:pt>
                  <c:pt idx="5">
                    <c:v>4.2426406871192889E-2</c:v>
                  </c:pt>
                </c:numCache>
              </c:numRef>
            </c:minus>
          </c:errBars>
          <c:cat>
            <c:strRef>
              <c:f>Sheet1!$C$85:$C$90</c:f>
              <c:strCache>
                <c:ptCount val="6"/>
                <c:pt idx="0">
                  <c:v>total LDH </c:v>
                </c:pt>
                <c:pt idx="1">
                  <c:v>ctr CPZ</c:v>
                </c:pt>
                <c:pt idx="2">
                  <c:v>CPZ 2 µM</c:v>
                </c:pt>
                <c:pt idx="3">
                  <c:v>CPZ 4 µM</c:v>
                </c:pt>
                <c:pt idx="4">
                  <c:v>CPZ 20 µM</c:v>
                </c:pt>
                <c:pt idx="5">
                  <c:v>CPZ 80 µM</c:v>
                </c:pt>
              </c:strCache>
            </c:strRef>
          </c:cat>
          <c:val>
            <c:numRef>
              <c:f>Sheet1!$H$85:$H$90</c:f>
              <c:numCache>
                <c:formatCode>General</c:formatCode>
                <c:ptCount val="6"/>
                <c:pt idx="0">
                  <c:v>1.7250000000000001</c:v>
                </c:pt>
                <c:pt idx="1">
                  <c:v>0.29099999999999998</c:v>
                </c:pt>
                <c:pt idx="2">
                  <c:v>0.29900000000000004</c:v>
                </c:pt>
                <c:pt idx="3">
                  <c:v>0.34250000000000003</c:v>
                </c:pt>
                <c:pt idx="4">
                  <c:v>0.30300000000000005</c:v>
                </c:pt>
                <c:pt idx="5">
                  <c:v>0.52800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29120"/>
        <c:axId val="143091392"/>
      </c:barChart>
      <c:catAx>
        <c:axId val="1498291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091392"/>
        <c:crosses val="autoZero"/>
        <c:auto val="1"/>
        <c:lblAlgn val="ctr"/>
        <c:lblOffset val="100"/>
        <c:noMultiLvlLbl val="0"/>
      </c:catAx>
      <c:valAx>
        <c:axId val="1430913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0"/>
                </a:pPr>
                <a:r>
                  <a:rPr lang="en-US" b="0" i="0"/>
                  <a:t>absorba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98291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DFC91-B126-4A3E-9368-C6709E67190E}" type="datetimeFigureOut">
              <a:rPr lang="en-GB" smtClean="0"/>
              <a:pPr/>
              <a:t>21/05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4400" y="744538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81F276-B2E4-47CD-92F6-8F00017626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7428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81F276-B2E4-47CD-92F6-8F000176267D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69246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53F7F-49DD-4F66-9F20-F9E348023A27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892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16A20-350C-443A-A0FC-324D86E8863A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902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8C32-C9B7-4021-A4E4-27043C073977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6305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C1F21-FA1C-4F32-81CB-65195DAFAFD9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2580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3DBA9-E21B-48D8-892F-9725647D107E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732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D2CED-ACBC-4F65-AFE0-4F29AEBC576D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8459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9BB02-4115-40B8-A053-01F2226628EA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1746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AD5F7-6CE7-4EE2-8A35-5A0A440B2145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350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8078E-E874-427F-8F6A-B675BE7F38A2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33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DDE-6B83-4FE8-9C0F-A6BAD3A18422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812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825CD-8357-47B1-B469-5C9E971A72C0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45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9D0D4A-3801-47F0-820D-1E8900A26F11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875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611560" y="6309320"/>
            <a:ext cx="3456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1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1</a:t>
            </a:fld>
            <a:endParaRPr lang="en-GB"/>
          </a:p>
        </p:txBody>
      </p:sp>
      <p:sp>
        <p:nvSpPr>
          <p:cNvPr id="8" name="TextBox 7"/>
          <p:cNvSpPr txBox="1"/>
          <p:nvPr/>
        </p:nvSpPr>
        <p:spPr>
          <a:xfrm>
            <a:off x="4837225" y="260648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938799" y="2564904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938799" y="332656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8235283"/>
              </p:ext>
            </p:extLst>
          </p:nvPr>
        </p:nvGraphicFramePr>
        <p:xfrm>
          <a:off x="913490" y="415661"/>
          <a:ext cx="3393377" cy="18824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3971448"/>
              </p:ext>
            </p:extLst>
          </p:nvPr>
        </p:nvGraphicFramePr>
        <p:xfrm>
          <a:off x="4788024" y="260648"/>
          <a:ext cx="3276364" cy="1872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1079750"/>
              </p:ext>
            </p:extLst>
          </p:nvPr>
        </p:nvGraphicFramePr>
        <p:xfrm>
          <a:off x="938799" y="2477459"/>
          <a:ext cx="3197358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1786300"/>
              </p:ext>
            </p:extLst>
          </p:nvPr>
        </p:nvGraphicFramePr>
        <p:xfrm>
          <a:off x="4860032" y="2420889"/>
          <a:ext cx="3197358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2496333"/>
              </p:ext>
            </p:extLst>
          </p:nvPr>
        </p:nvGraphicFramePr>
        <p:xfrm>
          <a:off x="619183" y="4515437"/>
          <a:ext cx="3600400" cy="19468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6493487"/>
              </p:ext>
            </p:extLst>
          </p:nvPr>
        </p:nvGraphicFramePr>
        <p:xfrm>
          <a:off x="4608004" y="4365104"/>
          <a:ext cx="3582144" cy="20196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4782084" y="4393452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803598" y="4509120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E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4871731" y="2452246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223083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77</TotalTime>
  <Words>41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lowska, Ewa</dc:creator>
  <cp:lastModifiedBy>Ewa Szalowska</cp:lastModifiedBy>
  <cp:revision>271</cp:revision>
  <cp:lastPrinted>2012-12-19T13:50:48Z</cp:lastPrinted>
  <dcterms:created xsi:type="dcterms:W3CDTF">2012-10-29T11:33:36Z</dcterms:created>
  <dcterms:modified xsi:type="dcterms:W3CDTF">2013-05-21T11:21:32Z</dcterms:modified>
</cp:coreProperties>
</file>